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120" y="-21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blic\Documents\FAMRI%20Project%20Data\FAMRI%20Histology\Histology%20Data%20for%20Graphing%20-%20Athero%20article%202017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blic\Documents\FAMRI%20Project%20Data\FAMRI%20Histology\Histology%20Data%20for%20Graphing%20-%20Athero%20article%202017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nominate</a:t>
            </a:r>
            <a:r>
              <a:rPr lang="en-US" sz="14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Artery</a:t>
            </a:r>
          </a:p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Matrix Positive Staining 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ovat’s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7114298563222222"/>
          <c:y val="2.6315789473684209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011414946707217"/>
          <c:y val="0.18322316618317447"/>
          <c:w val="0.8411796293445466"/>
          <c:h val="0.70079707141870429"/>
        </c:manualLayout>
      </c:layout>
      <c:barChart>
        <c:barDir val="col"/>
        <c:grouping val="clustered"/>
        <c:varyColors val="0"/>
        <c:ser>
          <c:idx val="6"/>
          <c:order val="6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Movat 9wks '!$B$29:$C$29</c:f>
                <c:numCache>
                  <c:formatCode>General</c:formatCode>
                  <c:ptCount val="2"/>
                  <c:pt idx="0">
                    <c:v>0.12183777921664705</c:v>
                  </c:pt>
                  <c:pt idx="1">
                    <c:v>0.27131367660166172</c:v>
                  </c:pt>
                </c:numCache>
              </c:numRef>
            </c:plus>
            <c:minus>
              <c:numRef>
                <c:f>'Movat 9wks '!$B$29:$C$29</c:f>
                <c:numCache>
                  <c:formatCode>General</c:formatCode>
                  <c:ptCount val="2"/>
                  <c:pt idx="0">
                    <c:v>0.12183777921664705</c:v>
                  </c:pt>
                  <c:pt idx="1">
                    <c:v>0.27131367660166172</c:v>
                  </c:pt>
                </c:numCache>
              </c:numRef>
            </c:minus>
          </c:errBars>
          <c:cat>
            <c:numRef>
              <c:f>'Movat 9wks '!$B$19:$C$19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cat>
          <c:val>
            <c:numRef>
              <c:f>'Movat 9wks '!$B$27:$C$27</c:f>
              <c:numCache>
                <c:formatCode>General</c:formatCode>
                <c:ptCount val="2"/>
                <c:pt idx="0">
                  <c:v>1.1866666666666668</c:v>
                </c:pt>
                <c:pt idx="1">
                  <c:v>1.416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095296"/>
        <c:axId val="37098240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9wks '!$A$18,'Movat 9wks '!$C$18)</c:f>
              <c:numCache>
                <c:formatCode>General</c:formatCode>
                <c:ptCount val="2"/>
                <c:pt idx="0">
                  <c:v>0.96</c:v>
                </c:pt>
                <c:pt idx="1">
                  <c:v>1.96</c:v>
                </c:pt>
              </c:numCache>
            </c:numRef>
          </c:xVal>
          <c:yVal>
            <c:numRef>
              <c:f>'Movat 9wks '!$B$21:$C$21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9wks '!$B$19:$C$19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Movat 9wks '!$B$22:$C$22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9wks '!$B$18,'Movat 9wks '!$D$18)</c:f>
              <c:numCache>
                <c:formatCode>General</c:formatCode>
                <c:ptCount val="2"/>
                <c:pt idx="0">
                  <c:v>1.0349999999999999</c:v>
                </c:pt>
                <c:pt idx="1">
                  <c:v>2.04</c:v>
                </c:pt>
              </c:numCache>
            </c:numRef>
          </c:xVal>
          <c:yVal>
            <c:numRef>
              <c:f>'Movat 9wks '!$B$23:$C$23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9wks '!$B$19:$C$19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Movat 9wks '!$B$24:$C$24</c:f>
              <c:numCache>
                <c:formatCode>0.00</c:formatCode>
                <c:ptCount val="2"/>
                <c:pt idx="0">
                  <c:v>1.3333333333333333</c:v>
                </c:pt>
                <c:pt idx="1">
                  <c:v>2.3333333333333335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9wks '!$B$19:$C$19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Movat 9wks '!$B$25:$C$25</c:f>
              <c:numCache>
                <c:formatCode>0.00</c:formatCode>
                <c:ptCount val="2"/>
                <c:pt idx="0">
                  <c:v>1.6</c:v>
                </c:pt>
                <c:pt idx="1">
                  <c:v>1.75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xVal>
            <c:numRef>
              <c:f>'Movat 9wks '!$B$19:$C$19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Movat 9wks '!$B$26:$C$26</c:f>
              <c:numCache>
                <c:formatCode>General</c:formatCode>
                <c:ptCount val="2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095296"/>
        <c:axId val="37098240"/>
      </c:scatterChart>
      <c:catAx>
        <c:axId val="370952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7098240"/>
        <c:crosses val="autoZero"/>
        <c:auto val="1"/>
        <c:lblAlgn val="ctr"/>
        <c:lblOffset val="100"/>
        <c:noMultiLvlLbl val="0"/>
      </c:catAx>
      <c:valAx>
        <c:axId val="370982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stological Score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4.6183441599765328E-3"/>
              <c:y val="0.2657425634295713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7095296"/>
        <c:crosses val="autoZero"/>
        <c:crossBetween val="between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nominate Artery</a:t>
            </a:r>
            <a:endParaRPr lang="en-US" sz="1400" baseline="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llagen Density</a:t>
            </a:r>
            <a:r>
              <a:rPr lang="en-US" sz="14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ovat’s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5678234665111305"/>
          <c:y val="2.640836833366315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103742587732089"/>
          <c:y val="0.1836057403891041"/>
          <c:w val="0.85907018567123539"/>
          <c:h val="0.7004143895802698"/>
        </c:manualLayout>
      </c:layout>
      <c:barChart>
        <c:barDir val="col"/>
        <c:grouping val="clustered"/>
        <c:varyColors val="0"/>
        <c:ser>
          <c:idx val="6"/>
          <c:order val="6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Movat 9wks '!$B$14:$C$14</c:f>
                <c:numCache>
                  <c:formatCode>General</c:formatCode>
                  <c:ptCount val="2"/>
                  <c:pt idx="0">
                    <c:v>0.299768429143416</c:v>
                  </c:pt>
                  <c:pt idx="1">
                    <c:v>0.29344694769431706</c:v>
                  </c:pt>
                </c:numCache>
              </c:numRef>
            </c:plus>
            <c:minus>
              <c:numRef>
                <c:f>'Movat 9wks '!$B$14:$C$14</c:f>
                <c:numCache>
                  <c:formatCode>General</c:formatCode>
                  <c:ptCount val="2"/>
                  <c:pt idx="0">
                    <c:v>0.299768429143416</c:v>
                  </c:pt>
                  <c:pt idx="1">
                    <c:v>0.29344694769431706</c:v>
                  </c:pt>
                </c:numCache>
              </c:numRef>
            </c:minus>
          </c:errBars>
          <c:cat>
            <c:numRef>
              <c:f>'Movat 9wks '!$B$4:$C$4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cat>
          <c:val>
            <c:numRef>
              <c:f>'Movat 9wks '!$B$12:$C$12</c:f>
              <c:numCache>
                <c:formatCode>0.00</c:formatCode>
                <c:ptCount val="2"/>
                <c:pt idx="0" formatCode="General">
                  <c:v>1.4833333333333332</c:v>
                </c:pt>
                <c:pt idx="1">
                  <c:v>2.08333333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188160"/>
        <c:axId val="38189696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9wks '!$A$3,'Movat 9wks '!$C$4)</c:f>
              <c:numCache>
                <c:formatCode>General</c:formatCode>
                <c:ptCount val="2"/>
                <c:pt idx="0">
                  <c:v>0.96499999999999997</c:v>
                </c:pt>
                <c:pt idx="1">
                  <c:v>2</c:v>
                </c:pt>
              </c:numCache>
            </c:numRef>
          </c:xVal>
          <c:yVal>
            <c:numRef>
              <c:f>'Movat 9wks '!$B$6:$C$6</c:f>
              <c:numCache>
                <c:formatCode>0.00</c:formatCode>
                <c:ptCount val="2"/>
                <c:pt idx="0">
                  <c:v>1.25</c:v>
                </c:pt>
                <c:pt idx="1">
                  <c:v>2.25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9wks '!$B$4:$C$4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Movat 9wks '!$B$7:$C$7</c:f>
              <c:numCache>
                <c:formatCode>0.00</c:formatCode>
                <c:ptCount val="2"/>
                <c:pt idx="0">
                  <c:v>1.25</c:v>
                </c:pt>
                <c:pt idx="1">
                  <c:v>2.5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9wks '!$B$3,'Movat 9wks '!$C$4)</c:f>
              <c:numCache>
                <c:formatCode>General</c:formatCode>
                <c:ptCount val="2"/>
                <c:pt idx="0">
                  <c:v>1.04</c:v>
                </c:pt>
                <c:pt idx="1">
                  <c:v>2</c:v>
                </c:pt>
              </c:numCache>
            </c:numRef>
          </c:xVal>
          <c:yVal>
            <c:numRef>
              <c:f>'Movat 9wks '!$B$8:$C$8</c:f>
              <c:numCache>
                <c:formatCode>0.00</c:formatCode>
                <c:ptCount val="2"/>
                <c:pt idx="0">
                  <c:v>1.25</c:v>
                </c:pt>
                <c:pt idx="1">
                  <c:v>2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9wks '!$B$4:$C$4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Movat 9wks '!$B$9:$C$9</c:f>
              <c:numCache>
                <c:formatCode>0.00</c:formatCode>
                <c:ptCount val="2"/>
                <c:pt idx="0">
                  <c:v>2.6666666666666665</c:v>
                </c:pt>
                <c:pt idx="1">
                  <c:v>2.6666666666666665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9wks '!$B$4:$C$4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Movat 9wks '!$B$10:$C$10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xVal>
            <c:numRef>
              <c:f>'Movat 9wks '!$B$4:$C$4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Movat 9wks '!$B$11:$C$11</c:f>
              <c:numCache>
                <c:formatCode>General</c:formatCode>
                <c:ptCount val="2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188160"/>
        <c:axId val="38189696"/>
      </c:scatterChart>
      <c:catAx>
        <c:axId val="38188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8189696"/>
        <c:crosses val="autoZero"/>
        <c:auto val="1"/>
        <c:lblAlgn val="ctr"/>
        <c:lblOffset val="100"/>
        <c:noMultiLvlLbl val="0"/>
      </c:catAx>
      <c:valAx>
        <c:axId val="381896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stological Score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4545056867891514E-3"/>
              <c:y val="0.2632425634295713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8188160"/>
        <c:crosses val="autoZero"/>
        <c:crossBetween val="between"/>
        <c:majorUnit val="1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nominate</a:t>
            </a:r>
            <a:r>
              <a:rPr lang="en-US" sz="14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Artery Lesion Area 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RO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9175925925925927"/>
          <c:y val="2.7777777777777776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838424710800039"/>
          <c:y val="0.13936351706036745"/>
          <c:w val="0.79965052979488682"/>
          <c:h val="0.74465660542432199"/>
        </c:manualLayout>
      </c:layout>
      <c:barChart>
        <c:barDir val="col"/>
        <c:grouping val="clustered"/>
        <c:varyColors val="0"/>
        <c:ser>
          <c:idx val="6"/>
          <c:order val="6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9wk Treatment ORO Plaque Area'!$B$14:$C$14</c:f>
                <c:numCache>
                  <c:formatCode>General</c:formatCode>
                  <c:ptCount val="2"/>
                  <c:pt idx="0">
                    <c:v>5241.3167676071616</c:v>
                  </c:pt>
                  <c:pt idx="1">
                    <c:v>3905.3523280428885</c:v>
                  </c:pt>
                </c:numCache>
              </c:numRef>
            </c:plus>
            <c:minus>
              <c:numRef>
                <c:f>'9wk Treatment ORO Plaque Area'!$B$14:$C$14</c:f>
                <c:numCache>
                  <c:formatCode>General</c:formatCode>
                  <c:ptCount val="2"/>
                  <c:pt idx="0">
                    <c:v>5241.3167676071616</c:v>
                  </c:pt>
                  <c:pt idx="1">
                    <c:v>3905.3523280428885</c:v>
                  </c:pt>
                </c:numCache>
              </c:numRef>
            </c:minus>
          </c:errBars>
          <c:cat>
            <c:numRef>
              <c:f>'9wk Treatment ORO Plaque Area'!$B$4:$C$4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cat>
          <c:val>
            <c:numRef>
              <c:f>'9wk Treatment ORO Plaque Area'!$B$12:$C$12</c:f>
              <c:numCache>
                <c:formatCode>General</c:formatCode>
                <c:ptCount val="2"/>
                <c:pt idx="0">
                  <c:v>23830.97</c:v>
                </c:pt>
                <c:pt idx="1">
                  <c:v>14170.3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033088"/>
        <c:axId val="41906944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9wk Treatment ORO Plaque Area'!$B$4:$C$4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9wk Treatment ORO Plaque Area'!$B$6:$C$6</c:f>
              <c:numCache>
                <c:formatCode>General</c:formatCode>
                <c:ptCount val="2"/>
                <c:pt idx="0">
                  <c:v>12583</c:v>
                </c:pt>
                <c:pt idx="1">
                  <c:v>3539.75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9wk Treatment ORO Plaque Area'!$B$3,'9wk Treatment ORO Plaque Area'!$C$4)</c:f>
              <c:numCache>
                <c:formatCode>General</c:formatCode>
                <c:ptCount val="2"/>
                <c:pt idx="0">
                  <c:v>0.97499999999999998</c:v>
                </c:pt>
                <c:pt idx="1">
                  <c:v>2</c:v>
                </c:pt>
              </c:numCache>
            </c:numRef>
          </c:xVal>
          <c:yVal>
            <c:numRef>
              <c:f>'9wk Treatment ORO Plaque Area'!$B$7:$C$7</c:f>
              <c:numCache>
                <c:formatCode>General</c:formatCode>
                <c:ptCount val="2"/>
                <c:pt idx="0">
                  <c:v>22782.5</c:v>
                </c:pt>
                <c:pt idx="1">
                  <c:v>25402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9wk Treatment ORO Plaque Area'!$C$3,'9wk Treatment ORO Plaque Area'!$C$4)</c:f>
              <c:numCache>
                <c:formatCode>General</c:formatCode>
                <c:ptCount val="2"/>
                <c:pt idx="0">
                  <c:v>1.0249999999999999</c:v>
                </c:pt>
                <c:pt idx="1">
                  <c:v>2</c:v>
                </c:pt>
              </c:numCache>
            </c:numRef>
          </c:xVal>
          <c:yVal>
            <c:numRef>
              <c:f>'9wk Treatment ORO Plaque Area'!$B$8:$C$8</c:f>
              <c:numCache>
                <c:formatCode>General</c:formatCode>
                <c:ptCount val="2"/>
                <c:pt idx="0">
                  <c:v>22737.75</c:v>
                </c:pt>
                <c:pt idx="1">
                  <c:v>8963.7999999999993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9wk Treatment ORO Plaque Area'!$B$4:$C$4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9wk Treatment ORO Plaque Area'!$B$9:$C$9</c:f>
              <c:numCache>
                <c:formatCode>General</c:formatCode>
                <c:ptCount val="2"/>
                <c:pt idx="0">
                  <c:v>43390</c:v>
                </c:pt>
                <c:pt idx="1">
                  <c:v>20225.599999999999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9wk Treatment ORO Plaque Area'!$B$4:$C$4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9wk Treatment ORO Plaque Area'!$B$10:$C$10</c:f>
              <c:numCache>
                <c:formatCode>General</c:formatCode>
                <c:ptCount val="2"/>
                <c:pt idx="0">
                  <c:v>17661.599999999999</c:v>
                </c:pt>
                <c:pt idx="1">
                  <c:v>12720.625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xVal>
            <c:numRef>
              <c:f>'9wk Treatment ORO Plaque Area'!$B$4:$C$4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9wk Treatment ORO Plaque Area'!$B$11:$C$11</c:f>
              <c:numCache>
                <c:formatCode>General</c:formatCode>
                <c:ptCount val="2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033088"/>
        <c:axId val="41906944"/>
      </c:scatterChart>
      <c:catAx>
        <c:axId val="390330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41906944"/>
        <c:crosses val="autoZero"/>
        <c:auto val="1"/>
        <c:lblAlgn val="ctr"/>
        <c:lblOffset val="100"/>
        <c:noMultiLvlLbl val="0"/>
      </c:catAx>
      <c:valAx>
        <c:axId val="419069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esion Area</a:t>
                </a: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l-GR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²)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4535821911149994E-3"/>
              <c:y val="0.2980457130358705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9033088"/>
        <c:crosses val="autoZero"/>
        <c:crossBetween val="between"/>
        <c:majorUnit val="10000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351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5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607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866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387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324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757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585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22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196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152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335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>
            <a:spLocks noGrp="1"/>
          </p:cNvSpPr>
          <p:nvPr>
            <p:ph type="title"/>
          </p:nvPr>
        </p:nvSpPr>
        <p:spPr>
          <a:xfrm>
            <a:off x="457200" y="76200"/>
            <a:ext cx="8229600" cy="609600"/>
          </a:xfrm>
        </p:spPr>
        <p:txBody>
          <a:bodyPr>
            <a:noAutofit/>
          </a:bodyPr>
          <a:lstStyle/>
          <a:p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7 Fig (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Figs 8A and 8B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Movat, ORO - Innominate Artery)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4795684" y="3872066"/>
            <a:ext cx="4124855" cy="2966269"/>
            <a:chOff x="304800" y="914400"/>
            <a:chExt cx="4124855" cy="2966269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57356773"/>
                </p:ext>
              </p:extLst>
            </p:nvPr>
          </p:nvGraphicFramePr>
          <p:xfrm>
            <a:off x="304800" y="914400"/>
            <a:ext cx="4124855" cy="2895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1020618" y="3449782"/>
              <a:ext cx="32004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WD + SHS                            WD + SHS</a:t>
              </a:r>
            </a:p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Control                            Ly6G:siMMP-9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381000" y="3872068"/>
            <a:ext cx="4114800" cy="2966267"/>
            <a:chOff x="4648200" y="990600"/>
            <a:chExt cx="4114800" cy="2966267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50508350"/>
                </p:ext>
              </p:extLst>
            </p:nvPr>
          </p:nvGraphicFramePr>
          <p:xfrm>
            <a:off x="4648200" y="990600"/>
            <a:ext cx="4114800" cy="288544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8" name="TextBox 7"/>
            <p:cNvSpPr txBox="1"/>
            <p:nvPr/>
          </p:nvSpPr>
          <p:spPr>
            <a:xfrm>
              <a:off x="5285509" y="3525980"/>
              <a:ext cx="32004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WD + SHS                             WD + SHS</a:t>
              </a:r>
            </a:p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Control                             Ly6G:siMMP-9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2362200" y="762000"/>
            <a:ext cx="4114800" cy="2806942"/>
            <a:chOff x="2514600" y="3886200"/>
            <a:chExt cx="4114800" cy="2806942"/>
          </a:xfrm>
        </p:grpSpPr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28642566"/>
                </p:ext>
              </p:extLst>
            </p:nvPr>
          </p:nvGraphicFramePr>
          <p:xfrm>
            <a:off x="2514600" y="3886200"/>
            <a:ext cx="41148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9" name="TextBox 8"/>
            <p:cNvSpPr txBox="1"/>
            <p:nvPr/>
          </p:nvSpPr>
          <p:spPr>
            <a:xfrm>
              <a:off x="3352800" y="6262255"/>
              <a:ext cx="32004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WD + SHS                          WD + SHS</a:t>
              </a:r>
            </a:p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Control                           Ly6G:siMMP-9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2561122" y="68580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800600" y="396240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08709" y="396240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1429413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79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7 Fig (Figs 8A and 8B Movat, ORO - Innominate Artery)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1 Figure (Fig 1A -7wk ORO Staining)</dc:title>
  <dc:creator>Florence, Jon</dc:creator>
  <cp:lastModifiedBy>Florence, Jon</cp:lastModifiedBy>
  <cp:revision>10</cp:revision>
  <dcterms:created xsi:type="dcterms:W3CDTF">2017-01-26T23:47:11Z</dcterms:created>
  <dcterms:modified xsi:type="dcterms:W3CDTF">2017-01-26T23:59:51Z</dcterms:modified>
</cp:coreProperties>
</file>